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1" r:id="rId2"/>
    <p:sldId id="262" r:id="rId3"/>
    <p:sldId id="263" r:id="rId4"/>
    <p:sldId id="264" r:id="rId5"/>
    <p:sldId id="260" r:id="rId6"/>
  </p:sldIdLst>
  <p:sldSz cx="12192000" cy="6858000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 snapToObjects="1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38DCEFBF-6278-4A48-AC2E-A424B6812B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Podtytuł 2">
            <a:extLst>
              <a:ext uri="{FF2B5EF4-FFF2-40B4-BE49-F238E27FC236}">
                <a16:creationId xmlns:a16="http://schemas.microsoft.com/office/drawing/2014/main" id="{5922414C-3B54-424B-A626-C29BFBB748F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/>
              <a:t>Kliknij, aby edytować styl wzorca podtytułu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B77457F0-792C-7D4E-8F08-AD035F7430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AE056-1E6B-F947-8161-9DA21E8B4069}" type="datetimeFigureOut">
              <a:rPr lang="pl-PL" smtClean="0"/>
              <a:t>23.01.2021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CB6CBEA0-772C-DC43-8AA5-51874F0904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83E54D29-EA0F-DF43-B061-3356B65651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B212B-E2E0-F544-880B-6B5FC3F25043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7695198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E030E671-A867-DB44-BCAF-6FFF2FEC90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>
            <a:extLst>
              <a:ext uri="{FF2B5EF4-FFF2-40B4-BE49-F238E27FC236}">
                <a16:creationId xmlns:a16="http://schemas.microsoft.com/office/drawing/2014/main" id="{50A4E050-5FD5-5440-ABEB-8259E06B1E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2D1C38CC-E360-6646-B6A3-574555C8E6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AE056-1E6B-F947-8161-9DA21E8B4069}" type="datetimeFigureOut">
              <a:rPr lang="pl-PL" smtClean="0"/>
              <a:t>23.01.2021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BADEDB90-80B9-3C48-8C1F-D0BAC532B1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F724D9F4-C09F-2543-AFA3-D8141ECC63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B212B-E2E0-F544-880B-6B5FC3F25043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0298773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>
            <a:extLst>
              <a:ext uri="{FF2B5EF4-FFF2-40B4-BE49-F238E27FC236}">
                <a16:creationId xmlns:a16="http://schemas.microsoft.com/office/drawing/2014/main" id="{D5782287-B350-3242-A16B-C07F9334568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>
            <a:extLst>
              <a:ext uri="{FF2B5EF4-FFF2-40B4-BE49-F238E27FC236}">
                <a16:creationId xmlns:a16="http://schemas.microsoft.com/office/drawing/2014/main" id="{F5AC1ED3-5F34-8446-98CD-2A7AC9905C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16D11272-0D1D-DA4C-8B55-2A780B1E1D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AE056-1E6B-F947-8161-9DA21E8B4069}" type="datetimeFigureOut">
              <a:rPr lang="pl-PL" smtClean="0"/>
              <a:t>23.01.2021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C1E9B726-6021-B04B-A2BD-8B7A193111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D560A50A-3A19-9A40-8C42-FC87ED4059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B212B-E2E0-F544-880B-6B5FC3F25043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4606806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197D00BF-E213-9043-B28C-BEE3EA153B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60FD6040-098F-374D-8B8B-44424516086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1E88797D-DBD9-5B41-9230-EBA735EF8A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AE056-1E6B-F947-8161-9DA21E8B4069}" type="datetimeFigureOut">
              <a:rPr lang="pl-PL" smtClean="0"/>
              <a:t>23.01.2021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302F3BD0-4891-E646-A75A-44FBE65E10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D06AFDBA-3956-FD4E-8779-29488C4B21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B212B-E2E0-F544-880B-6B5FC3F25043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4210299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8B76618C-0C34-9448-AEE0-53194ADD6E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id="{E22FA6AA-779B-DA4C-ABF0-F0224AAE4C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C27B2732-C940-2141-BC60-7EF571F84E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AE056-1E6B-F947-8161-9DA21E8B4069}" type="datetimeFigureOut">
              <a:rPr lang="pl-PL" smtClean="0"/>
              <a:t>23.01.2021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B6BA3CB1-DA3C-D449-8725-0AF732C18D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01881089-26B5-E745-B4CC-35404E4C2B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B212B-E2E0-F544-880B-6B5FC3F25043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2116277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BAED7D8E-FB14-E144-8629-94F8413BB0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CCF77638-2861-0342-BD58-124576E3821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zawartości 3">
            <a:extLst>
              <a:ext uri="{FF2B5EF4-FFF2-40B4-BE49-F238E27FC236}">
                <a16:creationId xmlns:a16="http://schemas.microsoft.com/office/drawing/2014/main" id="{C7E460C7-D585-FF43-B585-EEED9C8F26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id="{FBBF687C-65FE-5041-9775-7C064B0C86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AE056-1E6B-F947-8161-9DA21E8B4069}" type="datetimeFigureOut">
              <a:rPr lang="pl-PL" smtClean="0"/>
              <a:t>23.01.2021</a:t>
            </a:fld>
            <a:endParaRPr lang="pl-PL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id="{7943314B-1114-1344-8E2C-12C2766E62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id="{AD9A2A06-BA57-8D41-ACA6-FB59D3CAEF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B212B-E2E0-F544-880B-6B5FC3F25043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9116477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C3F6566F-D677-D141-B321-35E00F7157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id="{F3500E7C-F439-A94D-A53A-8D5BD971E9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Symbol zastępczy zawartości 3">
            <a:extLst>
              <a:ext uri="{FF2B5EF4-FFF2-40B4-BE49-F238E27FC236}">
                <a16:creationId xmlns:a16="http://schemas.microsoft.com/office/drawing/2014/main" id="{A99B3E84-D78F-3646-9E9E-4B8B38212B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tekstu 4">
            <a:extLst>
              <a:ext uri="{FF2B5EF4-FFF2-40B4-BE49-F238E27FC236}">
                <a16:creationId xmlns:a16="http://schemas.microsoft.com/office/drawing/2014/main" id="{094435A8-DA3E-F941-A8CF-7A437DF6833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6" name="Symbol zastępczy zawartości 5">
            <a:extLst>
              <a:ext uri="{FF2B5EF4-FFF2-40B4-BE49-F238E27FC236}">
                <a16:creationId xmlns:a16="http://schemas.microsoft.com/office/drawing/2014/main" id="{9C905A6C-47DD-D04B-99DA-6FBCBA3A345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7" name="Symbol zastępczy daty 6">
            <a:extLst>
              <a:ext uri="{FF2B5EF4-FFF2-40B4-BE49-F238E27FC236}">
                <a16:creationId xmlns:a16="http://schemas.microsoft.com/office/drawing/2014/main" id="{AC620645-81E3-A749-BA11-7D72C40634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AE056-1E6B-F947-8161-9DA21E8B4069}" type="datetimeFigureOut">
              <a:rPr lang="pl-PL" smtClean="0"/>
              <a:t>23.01.2021</a:t>
            </a:fld>
            <a:endParaRPr lang="pl-PL"/>
          </a:p>
        </p:txBody>
      </p:sp>
      <p:sp>
        <p:nvSpPr>
          <p:cNvPr id="8" name="Symbol zastępczy stopki 7">
            <a:extLst>
              <a:ext uri="{FF2B5EF4-FFF2-40B4-BE49-F238E27FC236}">
                <a16:creationId xmlns:a16="http://schemas.microsoft.com/office/drawing/2014/main" id="{FC278691-5DE8-F845-9642-ACB38FA13C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>
            <a:extLst>
              <a:ext uri="{FF2B5EF4-FFF2-40B4-BE49-F238E27FC236}">
                <a16:creationId xmlns:a16="http://schemas.microsoft.com/office/drawing/2014/main" id="{7EEB8AE0-08B7-FF40-A341-6E1C9AD603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B212B-E2E0-F544-880B-6B5FC3F25043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7286573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ED62C35E-9238-DE4F-8B2D-34DA9AD3CB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daty 2">
            <a:extLst>
              <a:ext uri="{FF2B5EF4-FFF2-40B4-BE49-F238E27FC236}">
                <a16:creationId xmlns:a16="http://schemas.microsoft.com/office/drawing/2014/main" id="{9E1DE1DD-6709-9248-9AC6-AEDAE609BF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AE056-1E6B-F947-8161-9DA21E8B4069}" type="datetimeFigureOut">
              <a:rPr lang="pl-PL" smtClean="0"/>
              <a:t>23.01.2021</a:t>
            </a:fld>
            <a:endParaRPr lang="pl-PL"/>
          </a:p>
        </p:txBody>
      </p:sp>
      <p:sp>
        <p:nvSpPr>
          <p:cNvPr id="4" name="Symbol zastępczy stopki 3">
            <a:extLst>
              <a:ext uri="{FF2B5EF4-FFF2-40B4-BE49-F238E27FC236}">
                <a16:creationId xmlns:a16="http://schemas.microsoft.com/office/drawing/2014/main" id="{D75A9E35-7DB2-E042-8FD2-4BF96110DA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>
            <a:extLst>
              <a:ext uri="{FF2B5EF4-FFF2-40B4-BE49-F238E27FC236}">
                <a16:creationId xmlns:a16="http://schemas.microsoft.com/office/drawing/2014/main" id="{2A8BFE2F-C72A-5D40-A019-A93C5013C7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B212B-E2E0-F544-880B-6B5FC3F25043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2640831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>
            <a:extLst>
              <a:ext uri="{FF2B5EF4-FFF2-40B4-BE49-F238E27FC236}">
                <a16:creationId xmlns:a16="http://schemas.microsoft.com/office/drawing/2014/main" id="{6AAAAE0F-712F-254B-9B17-55F184B3FC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AE056-1E6B-F947-8161-9DA21E8B4069}" type="datetimeFigureOut">
              <a:rPr lang="pl-PL" smtClean="0"/>
              <a:t>23.01.2021</a:t>
            </a:fld>
            <a:endParaRPr lang="pl-PL"/>
          </a:p>
        </p:txBody>
      </p:sp>
      <p:sp>
        <p:nvSpPr>
          <p:cNvPr id="3" name="Symbol zastępczy stopki 2">
            <a:extLst>
              <a:ext uri="{FF2B5EF4-FFF2-40B4-BE49-F238E27FC236}">
                <a16:creationId xmlns:a16="http://schemas.microsoft.com/office/drawing/2014/main" id="{032C8AF6-C123-8643-B9DD-807A6AB371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>
            <a:extLst>
              <a:ext uri="{FF2B5EF4-FFF2-40B4-BE49-F238E27FC236}">
                <a16:creationId xmlns:a16="http://schemas.microsoft.com/office/drawing/2014/main" id="{9A9F21E0-387F-EB48-A24A-00CF7175AF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B212B-E2E0-F544-880B-6B5FC3F25043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7548901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C91C655B-2C0E-014B-BAD3-1FE0A1F461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26602263-97CA-434D-900F-3DAEADE328F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tekstu 3">
            <a:extLst>
              <a:ext uri="{FF2B5EF4-FFF2-40B4-BE49-F238E27FC236}">
                <a16:creationId xmlns:a16="http://schemas.microsoft.com/office/drawing/2014/main" id="{70EC6310-614B-2B4D-B437-1B9CE4BA67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id="{DA40E852-FC9D-614B-B14C-2D0FE8EE97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AE056-1E6B-F947-8161-9DA21E8B4069}" type="datetimeFigureOut">
              <a:rPr lang="pl-PL" smtClean="0"/>
              <a:t>23.01.2021</a:t>
            </a:fld>
            <a:endParaRPr lang="pl-PL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id="{A28A2E3F-130F-2D46-AE85-8AA7F9000B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id="{AE1513CB-A4C2-6342-8D5F-105B42695A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B212B-E2E0-F544-880B-6B5FC3F25043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5753070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90507F04-0A34-6248-8F8D-A3E256F92A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obrazu 2">
            <a:extLst>
              <a:ext uri="{FF2B5EF4-FFF2-40B4-BE49-F238E27FC236}">
                <a16:creationId xmlns:a16="http://schemas.microsoft.com/office/drawing/2014/main" id="{40B96F5B-357F-2F48-81D8-9D43DB5B6F1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>
            <a:extLst>
              <a:ext uri="{FF2B5EF4-FFF2-40B4-BE49-F238E27FC236}">
                <a16:creationId xmlns:a16="http://schemas.microsoft.com/office/drawing/2014/main" id="{619CE65B-9EFE-7B42-800B-219E6311AA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id="{4CA00A6C-2F52-9849-96F6-B2759C7A02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AE056-1E6B-F947-8161-9DA21E8B4069}" type="datetimeFigureOut">
              <a:rPr lang="pl-PL" smtClean="0"/>
              <a:t>23.01.2021</a:t>
            </a:fld>
            <a:endParaRPr lang="pl-PL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id="{FE4B17B4-545A-3B40-B788-F2C3D357AA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id="{77FFDFBE-9000-B14B-A159-C07F7668D2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B212B-E2E0-F544-880B-6B5FC3F25043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3322180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>
            <a:extLst>
              <a:ext uri="{FF2B5EF4-FFF2-40B4-BE49-F238E27FC236}">
                <a16:creationId xmlns:a16="http://schemas.microsoft.com/office/drawing/2014/main" id="{CABD7354-CF64-8A4E-8E59-A90A0CDC4D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id="{4DE4F683-8FCF-A543-8B0E-DE5CA0399B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784FA25E-D18C-0046-9861-6E5EF03F673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9AE056-1E6B-F947-8161-9DA21E8B4069}" type="datetimeFigureOut">
              <a:rPr lang="pl-PL" smtClean="0"/>
              <a:t>23.01.2021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645F301F-392D-8A44-A981-A5BFDC55BD2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50369426-DB0E-2148-9FD0-BDF5D2D58EC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4B212B-E2E0-F544-880B-6B5FC3F25043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8053148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http://127.0.0.1:52258/87ed211a-8c21-44e7-88b9-f804c2735678/36/res/34%20survival/resources/04ae6928553cbbfa.png" TargetMode="Externa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http://127.0.0.1:52258/87ed211a-8c21-44e7-88b9-f804c2735678/36/res/34%20survival/resources/c542087b27951e2b.png" TargetMode="External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http://127.0.0.1:52258/87ed211a-8c21-44e7-88b9-f804c2735678/24/res/24%20survival/resources/ab881b5dbca49209.png" TargetMode="External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http://127.0.0.1:52258/87ed211a-8c21-44e7-88b9-f804c2735678/28/res/28%20survival/resources/3bd1ff00c1b76c19.png" TargetMode="External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B2251A6A-8EC1-144F-902C-6CB08BB4F1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pl-PL" dirty="0" err="1">
                <a:latin typeface="Palatino Linotype" panose="02040502050505030304" pitchFamily="18" charset="0"/>
              </a:rPr>
              <a:t>Supplement</a:t>
            </a:r>
            <a:r>
              <a:rPr lang="pl-PL" dirty="0">
                <a:latin typeface="Palatino Linotype" panose="02040502050505030304" pitchFamily="18" charset="0"/>
              </a:rPr>
              <a:t> C: </a:t>
            </a:r>
            <a:r>
              <a:rPr lang="pl-PL" dirty="0" err="1">
                <a:latin typeface="Palatino Linotype" panose="02040502050505030304" pitchFamily="18" charset="0"/>
              </a:rPr>
              <a:t>survival</a:t>
            </a:r>
            <a:r>
              <a:rPr lang="pl-PL" dirty="0">
                <a:latin typeface="Palatino Linotype" panose="02040502050505030304" pitchFamily="18" charset="0"/>
              </a:rPr>
              <a:t> </a:t>
            </a:r>
            <a:r>
              <a:rPr lang="pl-PL" dirty="0" err="1">
                <a:latin typeface="Palatino Linotype" panose="02040502050505030304" pitchFamily="18" charset="0"/>
              </a:rPr>
              <a:t>curves</a:t>
            </a:r>
            <a:endParaRPr lang="pl-PL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052941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16AB3695-C484-6E44-9F07-A931446973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29510"/>
            <a:ext cx="10515600" cy="727236"/>
          </a:xfrm>
        </p:spPr>
        <p:txBody>
          <a:bodyPr>
            <a:normAutofit/>
          </a:bodyPr>
          <a:lstStyle/>
          <a:p>
            <a:pPr algn="ctr"/>
            <a:r>
              <a:rPr lang="pl-PL" sz="2800" dirty="0">
                <a:latin typeface="Palatino Linotype" panose="02040502050505030304" pitchFamily="18" charset="0"/>
              </a:rPr>
              <a:t>Time to </a:t>
            </a:r>
            <a:r>
              <a:rPr lang="pl-PL" sz="2800" dirty="0" err="1">
                <a:latin typeface="Palatino Linotype" panose="02040502050505030304" pitchFamily="18" charset="0"/>
              </a:rPr>
              <a:t>local</a:t>
            </a:r>
            <a:r>
              <a:rPr lang="pl-PL" sz="2800" dirty="0">
                <a:latin typeface="Palatino Linotype" panose="02040502050505030304" pitchFamily="18" charset="0"/>
              </a:rPr>
              <a:t> </a:t>
            </a:r>
            <a:r>
              <a:rPr lang="pl-PL" sz="2800" dirty="0" err="1">
                <a:latin typeface="Palatino Linotype" panose="02040502050505030304" pitchFamily="18" charset="0"/>
              </a:rPr>
              <a:t>progression</a:t>
            </a:r>
            <a:r>
              <a:rPr lang="pl-PL" sz="2800" dirty="0">
                <a:latin typeface="Palatino Linotype" panose="02040502050505030304" pitchFamily="18" charset="0"/>
              </a:rPr>
              <a:t> with 95% </a:t>
            </a:r>
            <a:r>
              <a:rPr lang="pl-PL" sz="2800" dirty="0" err="1">
                <a:latin typeface="Palatino Linotype" panose="02040502050505030304" pitchFamily="18" charset="0"/>
              </a:rPr>
              <a:t>confidence</a:t>
            </a:r>
            <a:r>
              <a:rPr lang="pl-PL" sz="2800" dirty="0">
                <a:latin typeface="Palatino Linotype" panose="02040502050505030304" pitchFamily="18" charset="0"/>
              </a:rPr>
              <a:t> </a:t>
            </a:r>
            <a:r>
              <a:rPr lang="pl-PL" sz="2800" dirty="0" err="1">
                <a:latin typeface="Palatino Linotype" panose="02040502050505030304" pitchFamily="18" charset="0"/>
              </a:rPr>
              <a:t>interval</a:t>
            </a:r>
            <a:endParaRPr lang="pl-PL" sz="2800" dirty="0">
              <a:latin typeface="Palatino Linotype" panose="02040502050505030304" pitchFamily="18" charset="0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A9107833-4254-E04E-B197-CA98AC628A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19865" y="1355073"/>
            <a:ext cx="21650856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pic>
        <p:nvPicPr>
          <p:cNvPr id="3073" name="Obraz 6" descr="Obraz zawierający stół&#10;&#10;Opis wygenerowany automatycznie">
            <a:extLst>
              <a:ext uri="{FF2B5EF4-FFF2-40B4-BE49-F238E27FC236}">
                <a16:creationId xmlns:a16="http://schemas.microsoft.com/office/drawing/2014/main" id="{06B6DD3C-6D97-444D-99FC-8DF44012079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r:link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6000" y="756746"/>
            <a:ext cx="7920000" cy="59278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1381831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16AB3695-C484-6E44-9F07-A931446973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0"/>
            <a:ext cx="10515600" cy="893379"/>
          </a:xfrm>
        </p:spPr>
        <p:txBody>
          <a:bodyPr>
            <a:normAutofit/>
          </a:bodyPr>
          <a:lstStyle/>
          <a:p>
            <a:pPr algn="ctr"/>
            <a:r>
              <a:rPr lang="pl-PL" sz="2800" dirty="0" err="1">
                <a:latin typeface="Palatino Linotype" panose="02040502050505030304" pitchFamily="18" charset="0"/>
              </a:rPr>
              <a:t>Local</a:t>
            </a:r>
            <a:r>
              <a:rPr lang="pl-PL" sz="2800" dirty="0">
                <a:latin typeface="Palatino Linotype" panose="02040502050505030304" pitchFamily="18" charset="0"/>
              </a:rPr>
              <a:t> </a:t>
            </a:r>
            <a:r>
              <a:rPr lang="pl-PL" sz="2800" dirty="0" err="1">
                <a:latin typeface="Palatino Linotype" panose="02040502050505030304" pitchFamily="18" charset="0"/>
              </a:rPr>
              <a:t>progression-free</a:t>
            </a:r>
            <a:r>
              <a:rPr lang="pl-PL" sz="2800" dirty="0">
                <a:latin typeface="Palatino Linotype" panose="02040502050505030304" pitchFamily="18" charset="0"/>
              </a:rPr>
              <a:t> </a:t>
            </a:r>
            <a:r>
              <a:rPr lang="pl-PL" sz="2800" dirty="0" err="1">
                <a:latin typeface="Palatino Linotype" panose="02040502050505030304" pitchFamily="18" charset="0"/>
              </a:rPr>
              <a:t>survival</a:t>
            </a:r>
            <a:r>
              <a:rPr lang="pl-PL" sz="2800" dirty="0">
                <a:latin typeface="Palatino Linotype" panose="02040502050505030304" pitchFamily="18" charset="0"/>
              </a:rPr>
              <a:t> with 95% </a:t>
            </a:r>
            <a:r>
              <a:rPr lang="pl-PL" sz="2800" dirty="0" err="1">
                <a:latin typeface="Palatino Linotype" panose="02040502050505030304" pitchFamily="18" charset="0"/>
              </a:rPr>
              <a:t>confidence</a:t>
            </a:r>
            <a:r>
              <a:rPr lang="pl-PL" sz="2800" dirty="0">
                <a:latin typeface="Palatino Linotype" panose="02040502050505030304" pitchFamily="18" charset="0"/>
              </a:rPr>
              <a:t> </a:t>
            </a:r>
            <a:r>
              <a:rPr lang="pl-PL" sz="2800" dirty="0" err="1">
                <a:latin typeface="Palatino Linotype" panose="02040502050505030304" pitchFamily="18" charset="0"/>
              </a:rPr>
              <a:t>interval</a:t>
            </a:r>
            <a:endParaRPr lang="pl-PL" sz="2800" dirty="0">
              <a:latin typeface="Palatino Linotype" panose="02040502050505030304" pitchFamily="18" charset="0"/>
            </a:endParaRP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A9AE4A9B-7821-324D-B341-433A2A3F15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pic>
        <p:nvPicPr>
          <p:cNvPr id="1027" name="Obraz 7" descr="Obraz zawierający stół&#10;&#10;Opis wygenerowany automatycznie">
            <a:extLst>
              <a:ext uri="{FF2B5EF4-FFF2-40B4-BE49-F238E27FC236}">
                <a16:creationId xmlns:a16="http://schemas.microsoft.com/office/drawing/2014/main" id="{38970872-9AB7-E54F-8D78-E48BED9D4EA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r:link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6000" y="789409"/>
            <a:ext cx="7920000" cy="593621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5092157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D6D5CF89-F029-2947-B5EC-A2C2BC4CCF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30068" y="1530816"/>
            <a:ext cx="23339534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pic>
        <p:nvPicPr>
          <p:cNvPr id="2049" name="Obraz 3" descr="Obraz zawierający stół&#10;&#10;Opis wygenerowany automatycznie">
            <a:extLst>
              <a:ext uri="{FF2B5EF4-FFF2-40B4-BE49-F238E27FC236}">
                <a16:creationId xmlns:a16="http://schemas.microsoft.com/office/drawing/2014/main" id="{EC9E9D06-446C-C844-B797-6043733AD9B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r:link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6000" y="893379"/>
            <a:ext cx="7920000" cy="59330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ytuł 1">
            <a:extLst>
              <a:ext uri="{FF2B5EF4-FFF2-40B4-BE49-F238E27FC236}">
                <a16:creationId xmlns:a16="http://schemas.microsoft.com/office/drawing/2014/main" id="{0D84D56D-249A-A24B-8B11-5465E3CA5603}"/>
              </a:ext>
            </a:extLst>
          </p:cNvPr>
          <p:cNvSpPr txBox="1">
            <a:spLocks/>
          </p:cNvSpPr>
          <p:nvPr/>
        </p:nvSpPr>
        <p:spPr>
          <a:xfrm>
            <a:off x="838200" y="0"/>
            <a:ext cx="10515600" cy="89337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pl-PL" sz="2800" dirty="0" err="1">
                <a:latin typeface="Palatino Linotype" panose="02040502050505030304" pitchFamily="18" charset="0"/>
              </a:rPr>
              <a:t>Sarcoma-specific</a:t>
            </a:r>
            <a:r>
              <a:rPr lang="pl-PL" sz="2800" dirty="0">
                <a:latin typeface="Palatino Linotype" panose="02040502050505030304" pitchFamily="18" charset="0"/>
              </a:rPr>
              <a:t> </a:t>
            </a:r>
            <a:r>
              <a:rPr lang="pl-PL" sz="2800" dirty="0" err="1">
                <a:latin typeface="Palatino Linotype" panose="02040502050505030304" pitchFamily="18" charset="0"/>
              </a:rPr>
              <a:t>survival</a:t>
            </a:r>
            <a:r>
              <a:rPr lang="pl-PL" sz="2800" dirty="0">
                <a:latin typeface="Palatino Linotype" panose="02040502050505030304" pitchFamily="18" charset="0"/>
              </a:rPr>
              <a:t> with 95% </a:t>
            </a:r>
            <a:r>
              <a:rPr lang="pl-PL" sz="2800" dirty="0" err="1">
                <a:latin typeface="Palatino Linotype" panose="02040502050505030304" pitchFamily="18" charset="0"/>
              </a:rPr>
              <a:t>confidence</a:t>
            </a:r>
            <a:r>
              <a:rPr lang="pl-PL" sz="2800" dirty="0">
                <a:latin typeface="Palatino Linotype" panose="02040502050505030304" pitchFamily="18" charset="0"/>
              </a:rPr>
              <a:t> </a:t>
            </a:r>
            <a:r>
              <a:rPr lang="pl-PL" sz="2800" dirty="0" err="1">
                <a:latin typeface="Palatino Linotype" panose="02040502050505030304" pitchFamily="18" charset="0"/>
              </a:rPr>
              <a:t>interval</a:t>
            </a:r>
            <a:endParaRPr lang="pl-PL" sz="28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599415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EAB769EE-941B-9949-B4CB-4BB7F3D3F9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58097" y="1690688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pic>
        <p:nvPicPr>
          <p:cNvPr id="4097" name="Obraz 5" descr="Obraz zawierający stół&#10;&#10;Opis wygenerowany automatycznie">
            <a:extLst>
              <a:ext uri="{FF2B5EF4-FFF2-40B4-BE49-F238E27FC236}">
                <a16:creationId xmlns:a16="http://schemas.microsoft.com/office/drawing/2014/main" id="{C27C57AE-8D9D-A04A-BEAB-A7D2FF278B0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r:link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6000" y="732384"/>
            <a:ext cx="7920000" cy="593217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ytuł 1">
            <a:extLst>
              <a:ext uri="{FF2B5EF4-FFF2-40B4-BE49-F238E27FC236}">
                <a16:creationId xmlns:a16="http://schemas.microsoft.com/office/drawing/2014/main" id="{AAE2FC7B-7CE4-3C43-A808-583A8CD4BAE4}"/>
              </a:ext>
            </a:extLst>
          </p:cNvPr>
          <p:cNvSpPr txBox="1">
            <a:spLocks/>
          </p:cNvSpPr>
          <p:nvPr/>
        </p:nvSpPr>
        <p:spPr>
          <a:xfrm>
            <a:off x="838200" y="0"/>
            <a:ext cx="10515600" cy="89337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pl-PL" sz="2800" dirty="0" err="1">
                <a:latin typeface="Palatino Linotype" panose="02040502050505030304" pitchFamily="18" charset="0"/>
              </a:rPr>
              <a:t>Progression-free</a:t>
            </a:r>
            <a:r>
              <a:rPr lang="pl-PL" sz="2800" dirty="0">
                <a:latin typeface="Palatino Linotype" panose="02040502050505030304" pitchFamily="18" charset="0"/>
              </a:rPr>
              <a:t> </a:t>
            </a:r>
            <a:r>
              <a:rPr lang="pl-PL" sz="2800" dirty="0" err="1">
                <a:latin typeface="Palatino Linotype" panose="02040502050505030304" pitchFamily="18" charset="0"/>
              </a:rPr>
              <a:t>survival</a:t>
            </a:r>
            <a:r>
              <a:rPr lang="pl-PL" sz="2800" dirty="0">
                <a:latin typeface="Palatino Linotype" panose="02040502050505030304" pitchFamily="18" charset="0"/>
              </a:rPr>
              <a:t> with 95% </a:t>
            </a:r>
            <a:r>
              <a:rPr lang="pl-PL" sz="2800" dirty="0" err="1">
                <a:latin typeface="Palatino Linotype" panose="02040502050505030304" pitchFamily="18" charset="0"/>
              </a:rPr>
              <a:t>confidence</a:t>
            </a:r>
            <a:r>
              <a:rPr lang="pl-PL" sz="2800" dirty="0">
                <a:latin typeface="Palatino Linotype" panose="02040502050505030304" pitchFamily="18" charset="0"/>
              </a:rPr>
              <a:t> </a:t>
            </a:r>
            <a:r>
              <a:rPr lang="pl-PL" sz="2800" dirty="0" err="1">
                <a:latin typeface="Palatino Linotype" panose="02040502050505030304" pitchFamily="18" charset="0"/>
              </a:rPr>
              <a:t>interval</a:t>
            </a:r>
            <a:endParaRPr lang="pl-PL" sz="28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62181139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36</Words>
  <Application>Microsoft Macintosh PowerPoint</Application>
  <PresentationFormat>Panoramiczny</PresentationFormat>
  <Paragraphs>5</Paragraphs>
  <Slides>5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4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Palatino Linotype</vt:lpstr>
      <vt:lpstr>Motyw pakietu Office</vt:lpstr>
      <vt:lpstr>Supplement C: survival curves</vt:lpstr>
      <vt:lpstr>Time to local progression with 95% confidence interval</vt:lpstr>
      <vt:lpstr>Local progression-free survival with 95% confidence interval</vt:lpstr>
      <vt:lpstr>Prezentacja programu PowerPoint</vt:lpstr>
      <vt:lpstr>Prezentacja programu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 C: survival curves</dc:title>
  <dc:creator>Mateusz Spałek</dc:creator>
  <cp:lastModifiedBy>Mateusz Spałek</cp:lastModifiedBy>
  <cp:revision>2</cp:revision>
  <dcterms:created xsi:type="dcterms:W3CDTF">2021-01-23T19:51:52Z</dcterms:created>
  <dcterms:modified xsi:type="dcterms:W3CDTF">2021-01-23T20:03:01Z</dcterms:modified>
</cp:coreProperties>
</file>